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824" y="-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3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3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699792" y="348235"/>
            <a:ext cx="3312368" cy="4001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Assessed for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eligibility(n=356) </a:t>
            </a:r>
            <a:endParaRPr lang="zh-CN" altLang="zh-CN" sz="2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" name="直接箭头连接符 5"/>
          <p:cNvCxnSpPr/>
          <p:nvPr/>
        </p:nvCxnSpPr>
        <p:spPr>
          <a:xfrm>
            <a:off x="4283968" y="748345"/>
            <a:ext cx="0" cy="1672543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箭头连接符 8"/>
          <p:cNvCxnSpPr/>
          <p:nvPr/>
        </p:nvCxnSpPr>
        <p:spPr>
          <a:xfrm>
            <a:off x="4283968" y="1538418"/>
            <a:ext cx="72008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5004048" y="836712"/>
            <a:ext cx="4032448" cy="144655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Excluded(n=20)</a:t>
            </a:r>
          </a:p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● 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Not meeting inclusion criteria(n=10)</a:t>
            </a:r>
          </a:p>
          <a:p>
            <a:r>
              <a:rPr lang="en-US" altLang="zh-CN" sz="800" dirty="0">
                <a:latin typeface="Times New Roman" pitchFamily="18" charset="0"/>
                <a:cs typeface="Times New Roman" pitchFamily="18" charset="0"/>
              </a:rPr>
              <a:t>●  </a:t>
            </a:r>
            <a:r>
              <a:rPr lang="en-US" altLang="zh-CN" sz="2000" dirty="0">
                <a:latin typeface="Times New Roman" pitchFamily="18" charset="0"/>
                <a:cs typeface="Times New Roman" pitchFamily="18" charset="0"/>
              </a:rPr>
              <a:t>Consent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refused(n=6)</a:t>
            </a:r>
          </a:p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●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 Other reasons(n=4)</a:t>
            </a:r>
          </a:p>
          <a:p>
            <a:endParaRPr lang="en-US" altLang="zh-CN" sz="8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699792" y="2435627"/>
            <a:ext cx="3384376" cy="4001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Enrolled(n=336)</a:t>
            </a:r>
            <a:endParaRPr lang="zh-CN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5" name="直接箭头连接符 14"/>
          <p:cNvCxnSpPr/>
          <p:nvPr/>
        </p:nvCxnSpPr>
        <p:spPr>
          <a:xfrm>
            <a:off x="3046918" y="2824634"/>
            <a:ext cx="0" cy="768057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箭头连接符 16"/>
          <p:cNvCxnSpPr/>
          <p:nvPr/>
        </p:nvCxnSpPr>
        <p:spPr>
          <a:xfrm>
            <a:off x="5940152" y="2824634"/>
            <a:ext cx="0" cy="768057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1367644" y="3592691"/>
            <a:ext cx="3096344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Nalbuphine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group(n=168)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716016" y="3592691"/>
            <a:ext cx="2952328" cy="4001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Fentanyl 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group(n=168)</a:t>
            </a:r>
            <a:endParaRPr lang="zh-CN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2" name="直接箭头连接符 21"/>
          <p:cNvCxnSpPr/>
          <p:nvPr/>
        </p:nvCxnSpPr>
        <p:spPr>
          <a:xfrm>
            <a:off x="3059832" y="3933056"/>
            <a:ext cx="0" cy="1562066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/>
          <p:cNvCxnSpPr/>
          <p:nvPr/>
        </p:nvCxnSpPr>
        <p:spPr>
          <a:xfrm flipH="1" flipV="1">
            <a:off x="2763484" y="4576008"/>
            <a:ext cx="296348" cy="2888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43102" y="4113307"/>
            <a:ext cx="2736304" cy="1200329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surgical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cancellation(n=4</a:t>
            </a:r>
            <a:r>
              <a:rPr lang="en-US" altLang="zh-CN" dirty="0" smtClean="0"/>
              <a:t>)</a:t>
            </a:r>
            <a:endParaRPr lang="en-US" altLang="zh-CN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Withdraw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consent(n=5)</a:t>
            </a: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Other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reasons(n=3)</a:t>
            </a: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ddictional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analgesia(n=2)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192180" y="4155499"/>
            <a:ext cx="2736304" cy="1200329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surgical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cancellation(n=3)</a:t>
            </a: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Withdraw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consent(n=4)</a:t>
            </a: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Other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reasons(n=2)</a:t>
            </a: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zh-CN" dirty="0" err="1" smtClean="0">
                <a:latin typeface="Times New Roman" pitchFamily="18" charset="0"/>
                <a:cs typeface="Times New Roman" pitchFamily="18" charset="0"/>
              </a:rPr>
              <a:t>ddictional</a:t>
            </a:r>
            <a:r>
              <a:rPr lang="en-US" altLang="zh-CN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mtClean="0">
                <a:latin typeface="Times New Roman" pitchFamily="18" charset="0"/>
                <a:cs typeface="Times New Roman" pitchFamily="18" charset="0"/>
              </a:rPr>
              <a:t>analgesia(n=2)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1" name="直接箭头连接符 30"/>
          <p:cNvCxnSpPr/>
          <p:nvPr/>
        </p:nvCxnSpPr>
        <p:spPr>
          <a:xfrm>
            <a:off x="5940152" y="3962021"/>
            <a:ext cx="0" cy="1533101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箭头连接符 33"/>
          <p:cNvCxnSpPr/>
          <p:nvPr/>
        </p:nvCxnSpPr>
        <p:spPr>
          <a:xfrm>
            <a:off x="5940152" y="4603370"/>
            <a:ext cx="252028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1414027" y="5495122"/>
            <a:ext cx="3096343" cy="4001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2000" dirty="0" err="1" smtClean="0">
                <a:latin typeface="Times New Roman" pitchFamily="18" charset="0"/>
                <a:cs typeface="Times New Roman" pitchFamily="18" charset="0"/>
              </a:rPr>
              <a:t>Nalbuphine</a:t>
            </a:r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 group(n=154)</a:t>
            </a:r>
            <a:endParaRPr lang="zh-CN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727578" y="5495122"/>
            <a:ext cx="2952328" cy="40011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dirty="0" smtClean="0">
                <a:latin typeface="Times New Roman" pitchFamily="18" charset="0"/>
                <a:cs typeface="Times New Roman" pitchFamily="18" charset="0"/>
              </a:rPr>
              <a:t>Fentanyl group(n=157)</a:t>
            </a:r>
            <a:endParaRPr lang="zh-CN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7180" y="6477450"/>
            <a:ext cx="9081324" cy="400110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Analysis</a:t>
            </a:r>
            <a:r>
              <a:rPr lang="en-US" altLang="zh-CN" dirty="0" smtClean="0"/>
              <a:t> </a:t>
            </a:r>
            <a:endParaRPr lang="zh-CN" altLang="en-US" dirty="0"/>
          </a:p>
        </p:txBody>
      </p:sp>
      <p:cxnSp>
        <p:nvCxnSpPr>
          <p:cNvPr id="40" name="直接箭头连接符 39"/>
          <p:cNvCxnSpPr/>
          <p:nvPr/>
        </p:nvCxnSpPr>
        <p:spPr>
          <a:xfrm flipH="1">
            <a:off x="3046918" y="5895232"/>
            <a:ext cx="12914" cy="582218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箭头连接符 41"/>
          <p:cNvCxnSpPr/>
          <p:nvPr/>
        </p:nvCxnSpPr>
        <p:spPr>
          <a:xfrm>
            <a:off x="5952255" y="5895232"/>
            <a:ext cx="0" cy="582218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827584" y="348235"/>
            <a:ext cx="1584176" cy="400110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Enrolled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631535" y="3008607"/>
            <a:ext cx="1584176" cy="400110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Allocation 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20554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</TotalTime>
  <Words>61</Words>
  <Application>Microsoft Office PowerPoint</Application>
  <PresentationFormat>全屏显示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gyu wang</dc:creator>
  <cp:lastModifiedBy>王呈雨</cp:lastModifiedBy>
  <cp:revision>15</cp:revision>
  <dcterms:created xsi:type="dcterms:W3CDTF">2019-09-23T12:13:53Z</dcterms:created>
  <dcterms:modified xsi:type="dcterms:W3CDTF">2020-03-25T04:58:49Z</dcterms:modified>
</cp:coreProperties>
</file>